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5716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50E51-4867-4B51-828E-9E06415034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822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303720"/>
            <a:ext cx="822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DA9CA-810A-4ED1-931E-31328FD443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33344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30372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30372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5011FD-77C0-4724-969F-DF728AFA20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264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333440"/>
            <a:ext cx="264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333440"/>
            <a:ext cx="264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303720"/>
            <a:ext cx="264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303720"/>
            <a:ext cx="264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303720"/>
            <a:ext cx="264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93D45-AE4A-4E8F-89DF-66A9630446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333440"/>
            <a:ext cx="8229600" cy="377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E28A9-989B-411B-BAD8-E0DEF62A41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8229600" cy="377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3A3D7-F8D8-4C83-BA79-53C54A4D65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4015800" cy="377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333440"/>
            <a:ext cx="4015800" cy="377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CCBAD4-169F-478E-B0B8-BA3E2D9FF5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6F418-C7FE-40CB-9D6D-CB04241421E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28600"/>
            <a:ext cx="8229600" cy="4416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809C0-2B24-4864-8585-E9082A3B7B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333440"/>
            <a:ext cx="4015800" cy="377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30372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911779-FA79-424C-87A1-EB82E25CF5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4015800" cy="377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33344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30372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B3AAA-845D-49F6-BB6C-5EA987B2F2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33344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333440"/>
            <a:ext cx="40158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303720"/>
            <a:ext cx="8229600" cy="179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D3296-232A-4C10-A184-16E738110F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52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333440"/>
            <a:ext cx="8229600" cy="3772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1000"/>
          </a:bodyPr>
          <a:p>
            <a:pPr marL="312120" indent="-3121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676080" indent="-2599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040040" indent="-20772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455840" indent="-20772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1872000" indent="-207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1872000" indent="-207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1872000" indent="-20772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5297040"/>
            <a:ext cx="2135160" cy="30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2640" y="5297040"/>
            <a:ext cx="2898720" cy="30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1280" y="5297040"/>
            <a:ext cx="2135160" cy="303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403D75-489C-43C9-9393-48AF4244DF5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00080" y="1057320"/>
            <a:ext cx="8956440" cy="3973320"/>
          </a:xfrm>
          <a:prstGeom prst="rect">
            <a:avLst/>
          </a:prstGeom>
          <a:ln w="0">
            <a:noFill/>
          </a:ln>
        </p:spPr>
      </p:pic>
      <p:sp>
        <p:nvSpPr>
          <p:cNvPr id="42" name="TextBox 1"/>
          <p:cNvSpPr/>
          <p:nvPr/>
        </p:nvSpPr>
        <p:spPr>
          <a:xfrm>
            <a:off x="9720" y="0"/>
            <a:ext cx="186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A. Import data fi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Box 1"/>
          <p:cNvSpPr/>
          <p:nvPr/>
        </p:nvSpPr>
        <p:spPr>
          <a:xfrm>
            <a:off x="20520" y="0"/>
            <a:ext cx="5008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J. Identify mutational signatures with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NM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" name="Picture 2" descr=""/>
          <p:cNvPicPr/>
          <p:nvPr/>
        </p:nvPicPr>
        <p:blipFill>
          <a:blip r:embed="rId1"/>
          <a:stretch/>
        </p:blipFill>
        <p:spPr>
          <a:xfrm>
            <a:off x="85680" y="622440"/>
            <a:ext cx="8950320" cy="497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TextBox 1"/>
          <p:cNvSpPr/>
          <p:nvPr/>
        </p:nvSpPr>
        <p:spPr>
          <a:xfrm>
            <a:off x="7200" y="0"/>
            <a:ext cx="242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K.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NMF 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outpu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2" name="Picture 3" descr=""/>
          <p:cNvPicPr/>
          <p:nvPr/>
        </p:nvPicPr>
        <p:blipFill>
          <a:blip r:embed="rId1"/>
          <a:stretch/>
        </p:blipFill>
        <p:spPr>
          <a:xfrm>
            <a:off x="81000" y="422280"/>
            <a:ext cx="8955000" cy="5243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1"/>
          <p:cNvSpPr/>
          <p:nvPr/>
        </p:nvSpPr>
        <p:spPr>
          <a:xfrm>
            <a:off x="24120" y="0"/>
            <a:ext cx="555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L. Compare mutational signatures with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Compar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3" descr=""/>
          <p:cNvPicPr/>
          <p:nvPr/>
        </p:nvPicPr>
        <p:blipFill>
          <a:blip r:embed="rId1"/>
          <a:stretch/>
        </p:blipFill>
        <p:spPr>
          <a:xfrm>
            <a:off x="74520" y="1201680"/>
            <a:ext cx="8961480" cy="418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TextBox 1"/>
          <p:cNvSpPr/>
          <p:nvPr/>
        </p:nvSpPr>
        <p:spPr>
          <a:xfrm>
            <a:off x="9720" y="0"/>
            <a:ext cx="289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.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Compare 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outpu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6" name="Picture 2" descr=""/>
          <p:cNvPicPr/>
          <p:nvPr/>
        </p:nvPicPr>
        <p:blipFill>
          <a:blip r:embed="rId1"/>
          <a:stretch/>
        </p:blipFill>
        <p:spPr>
          <a:xfrm>
            <a:off x="108000" y="1201680"/>
            <a:ext cx="8955000" cy="4186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1" descr=""/>
          <p:cNvPicPr/>
          <p:nvPr/>
        </p:nvPicPr>
        <p:blipFill>
          <a:blip r:embed="rId1"/>
          <a:stretch/>
        </p:blipFill>
        <p:spPr>
          <a:xfrm>
            <a:off x="34920" y="1217520"/>
            <a:ext cx="8956800" cy="3952800"/>
          </a:xfrm>
          <a:prstGeom prst="rect">
            <a:avLst/>
          </a:prstGeom>
          <a:ln w="0">
            <a:noFill/>
          </a:ln>
        </p:spPr>
      </p:pic>
      <p:sp>
        <p:nvSpPr>
          <p:cNvPr id="44" name="TextBox 2"/>
          <p:cNvSpPr/>
          <p:nvPr/>
        </p:nvSpPr>
        <p:spPr>
          <a:xfrm>
            <a:off x="29160" y="0"/>
            <a:ext cx="4051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B. Annotate data file with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Anno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1"/>
          <p:cNvSpPr/>
          <p:nvPr/>
        </p:nvSpPr>
        <p:spPr>
          <a:xfrm>
            <a:off x="37080" y="0"/>
            <a:ext cx="222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C. View annotated fil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Picture 1" descr=""/>
          <p:cNvPicPr/>
          <p:nvPr/>
        </p:nvPicPr>
        <p:blipFill>
          <a:blip r:embed="rId1"/>
          <a:stretch/>
        </p:blipFill>
        <p:spPr>
          <a:xfrm>
            <a:off x="28440" y="1488960"/>
            <a:ext cx="8955360" cy="3948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1"/>
          <p:cNvSpPr/>
          <p:nvPr/>
        </p:nvSpPr>
        <p:spPr>
          <a:xfrm>
            <a:off x="16200" y="0"/>
            <a:ext cx="3292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D. Filter SNPs with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Filte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8" name="Picture 1" descr=""/>
          <p:cNvPicPr/>
          <p:nvPr/>
        </p:nvPicPr>
        <p:blipFill>
          <a:blip r:embed="rId1"/>
          <a:stretch/>
        </p:blipFill>
        <p:spPr>
          <a:xfrm>
            <a:off x="81000" y="1417680"/>
            <a:ext cx="8955000" cy="394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TextBox 1"/>
          <p:cNvSpPr/>
          <p:nvPr/>
        </p:nvSpPr>
        <p:spPr>
          <a:xfrm>
            <a:off x="88200" y="0"/>
            <a:ext cx="8386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E. Split the filterd file into 106 sample files and create a file collection with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Spli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1"/>
          <a:stretch/>
        </p:blipFill>
        <p:spPr>
          <a:xfrm>
            <a:off x="85680" y="1273320"/>
            <a:ext cx="8950320" cy="3952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1"/>
          <p:cNvSpPr/>
          <p:nvPr/>
        </p:nvSpPr>
        <p:spPr>
          <a:xfrm>
            <a:off x="-2880" y="-4680"/>
            <a:ext cx="750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F. Compute statistics and generate an xls file with all data using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Stats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2" descr=""/>
          <p:cNvPicPr/>
          <p:nvPr/>
        </p:nvPicPr>
        <p:blipFill>
          <a:blip r:embed="rId1"/>
          <a:stretch/>
        </p:blipFill>
        <p:spPr>
          <a:xfrm>
            <a:off x="108000" y="1562040"/>
            <a:ext cx="8966160" cy="3903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1"/>
          <p:cNvSpPr/>
          <p:nvPr/>
        </p:nvSpPr>
        <p:spPr>
          <a:xfrm>
            <a:off x="19080" y="0"/>
            <a:ext cx="395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G.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Stats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 output: summary pa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Picture 1" descr=""/>
          <p:cNvPicPr/>
          <p:nvPr/>
        </p:nvPicPr>
        <p:blipFill>
          <a:blip r:embed="rId1"/>
          <a:stretch/>
        </p:blipFill>
        <p:spPr>
          <a:xfrm>
            <a:off x="152280" y="1488960"/>
            <a:ext cx="8956800" cy="3921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TextBox 2"/>
          <p:cNvSpPr/>
          <p:nvPr/>
        </p:nvSpPr>
        <p:spPr>
          <a:xfrm>
            <a:off x="18720" y="9360"/>
            <a:ext cx="3750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H.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Stats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 output: sample pag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Picture 2" descr=""/>
          <p:cNvPicPr/>
          <p:nvPr/>
        </p:nvPicPr>
        <p:blipFill>
          <a:blip r:embed="rId1"/>
          <a:stretch/>
        </p:blipFill>
        <p:spPr>
          <a:xfrm>
            <a:off x="108000" y="685800"/>
            <a:ext cx="8961480" cy="4908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Box 1"/>
          <p:cNvSpPr/>
          <p:nvPr/>
        </p:nvSpPr>
        <p:spPr>
          <a:xfrm>
            <a:off x="28440" y="0"/>
            <a:ext cx="809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I. </a:t>
            </a:r>
            <a:r>
              <a:rPr b="0" i="1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MutSpec-Stats</a:t>
            </a:r>
            <a:r>
              <a:rPr b="0" lang="fr-FR" sz="1800" spc="-1" strike="noStrike">
                <a:solidFill>
                  <a:srgbClr val="000000"/>
                </a:solidFill>
                <a:latin typeface="Calibri"/>
                <a:ea typeface="Arial"/>
              </a:rPr>
              <a:t> output: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Arial"/>
              </a:rPr>
              <a:t>Computed statistics for estimating the number of signature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Picture 2" descr=""/>
          <p:cNvPicPr/>
          <p:nvPr/>
        </p:nvPicPr>
        <p:blipFill>
          <a:blip r:embed="rId1"/>
          <a:stretch/>
        </p:blipFill>
        <p:spPr>
          <a:xfrm>
            <a:off x="225360" y="485640"/>
            <a:ext cx="8810640" cy="5180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29T07:33:28Z</dcterms:created>
  <dc:creator>Windows User</dc:creator>
  <dc:description/>
  <dc:language>en-US</dc:language>
  <cp:lastModifiedBy>Magali Olivier</cp:lastModifiedBy>
  <dcterms:modified xsi:type="dcterms:W3CDTF">2016-02-25T14:06:47Z</dcterms:modified>
  <cp:revision>24</cp:revision>
  <dc:subject/>
  <dc:title>PowerPoint Presentation</dc:title>
</cp:coreProperties>
</file>